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938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5588BF-9F19-4864-A15A-6E21FCB37275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C90849-94DD-4DA0-97CB-EA92AA6760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0018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C90849-94DD-4DA0-97CB-EA92AA67603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1842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031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116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20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201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523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225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192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442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619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618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842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886F5-EF2F-41B2-9C6F-EB00D50EC8FF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CD704-5FDA-471E-9E14-857A0100E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62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598149" y="538887"/>
            <a:ext cx="16194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413310" y="538887"/>
            <a:ext cx="1907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1504139" y="3269792"/>
            <a:ext cx="83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1504139" y="1360254"/>
            <a:ext cx="83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504139" y="5128336"/>
            <a:ext cx="83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y 7</a:t>
            </a: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54311" y="50899"/>
            <a:ext cx="2885181" cy="421115"/>
          </a:xfrm>
          <a:prstGeom prst="rect">
            <a:avLst/>
          </a:prstGeom>
        </p:spPr>
        <p:txBody>
          <a:bodyPr vert="horz" lIns="68580" tIns="34291" rIns="68580" bIns="34291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1370076"/>
              </p:ext>
            </p:extLst>
          </p:nvPr>
        </p:nvGraphicFramePr>
        <p:xfrm>
          <a:off x="1646773" y="447570"/>
          <a:ext cx="5937250" cy="622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1" name="Prism 7" r:id="rId4" imgW="3860295" imgH="4057135" progId="Prism7.Document">
                  <p:embed/>
                </p:oleObj>
              </mc:Choice>
              <mc:Fallback>
                <p:oleObj name="Prism 7" r:id="rId4" imgW="3860295" imgH="405713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46773" y="447570"/>
                        <a:ext cx="5937250" cy="6227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2199209" y="893781"/>
            <a:ext cx="28387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ranulocyte adhesion and diapedesis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199211" y="1175417"/>
            <a:ext cx="1851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XR/RXR Activation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199211" y="1472950"/>
            <a:ext cx="16054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L-10 signaling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199209" y="1772571"/>
            <a:ext cx="1414370" cy="2680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lycolysis I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199211" y="2073099"/>
            <a:ext cx="16054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38 MAPK signaling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037945" y="893781"/>
            <a:ext cx="19569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hrombin signaling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37945" y="1175417"/>
            <a:ext cx="20694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hospholipase C signaling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037945" y="1472950"/>
            <a:ext cx="14007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XCR4 signaling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037945" y="1775787"/>
            <a:ext cx="16873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hemokine signaling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037943" y="2073099"/>
            <a:ext cx="25334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actors promoting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ardiogenesis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204350" y="2817568"/>
            <a:ext cx="20062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Oxidative Phosphorylation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204350" y="3105432"/>
            <a:ext cx="20062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itochondrial Dysfunction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204350" y="3377537"/>
            <a:ext cx="20062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rtuin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Signaling Pathway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204350" y="3652141"/>
            <a:ext cx="13238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NA methylation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204350" y="3933863"/>
            <a:ext cx="10645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lycolysis I 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029588" y="2781376"/>
            <a:ext cx="20062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hrombin signaling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029588" y="3076822"/>
            <a:ext cx="20062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hospholipase C signaling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029588" y="3364618"/>
            <a:ext cx="25353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eukocyte extravasation signaling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029586" y="3641808"/>
            <a:ext cx="2849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granulocyte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adhesion and diapedesis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029588" y="3928168"/>
            <a:ext cx="20713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rotein kinase A signaling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194215" y="4619829"/>
            <a:ext cx="19988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AMP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mediated signaling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215221" y="4921729"/>
            <a:ext cx="19988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nhibition of MMPs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215221" y="5206012"/>
            <a:ext cx="24219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reatine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phosphate biosynthesis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215221" y="5493228"/>
            <a:ext cx="13983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PCR signaling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207214" y="5792834"/>
            <a:ext cx="1501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Relaxing signaling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029586" y="4619829"/>
            <a:ext cx="2849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granulocyte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adhesion and diapedesis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5036094" y="4921769"/>
            <a:ext cx="20713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rotein kinase A signaling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029588" y="5208699"/>
            <a:ext cx="19569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hrombin signaling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029588" y="5493228"/>
            <a:ext cx="14007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XCR4 signaling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5029586" y="5787060"/>
            <a:ext cx="28387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ranulocyte adhesion and diapedesi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697348" y="6346878"/>
            <a:ext cx="1212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log10 (p)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726477" y="6346878"/>
            <a:ext cx="1212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log10 (p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013280" y="2375386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146044" y="2375386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214084" y="2375386"/>
            <a:ext cx="455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848653" y="2375386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981417" y="2375386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7049457" y="2375386"/>
            <a:ext cx="455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013280" y="4240266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972742" y="4240266"/>
            <a:ext cx="455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990819" y="4240266"/>
            <a:ext cx="455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848653" y="4240266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790347" y="4240266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680961" y="4240266"/>
            <a:ext cx="455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015270" y="6125591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944516" y="6125591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3864135" y="6125591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851842" y="6125591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793536" y="6125591"/>
            <a:ext cx="30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684150" y="6125591"/>
            <a:ext cx="455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0086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5</TotalTime>
  <Words>120</Words>
  <Application>Microsoft Office PowerPoint</Application>
  <PresentationFormat>On-screen Show (4:3)</PresentationFormat>
  <Paragraphs>57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7</vt:lpstr>
      <vt:lpstr>PowerPoint Presentation</vt:lpstr>
    </vt:vector>
  </TitlesOfParts>
  <Company>UM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Mouton</dc:creator>
  <cp:lastModifiedBy>Merry Lindsey</cp:lastModifiedBy>
  <cp:revision>12</cp:revision>
  <dcterms:created xsi:type="dcterms:W3CDTF">2018-03-06T20:16:22Z</dcterms:created>
  <dcterms:modified xsi:type="dcterms:W3CDTF">2018-04-04T00:08:09Z</dcterms:modified>
</cp:coreProperties>
</file>